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3" r:id="rId2"/>
    <p:sldId id="262" r:id="rId3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599"/>
    <p:restoredTop sz="94586"/>
  </p:normalViewPr>
  <p:slideViewPr>
    <p:cSldViewPr snapToGrid="0" snapToObjects="1">
      <p:cViewPr varScale="1">
        <p:scale>
          <a:sx n="60" d="100"/>
          <a:sy n="60" d="100"/>
        </p:scale>
        <p:origin x="312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G:\plosone\manuscript\pathway%20graph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G:\plosone\manuscript\pathway%20graph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'air-graph'!$S$2</c:f>
              <c:strCache>
                <c:ptCount val="1"/>
                <c:pt idx="0">
                  <c:v>AB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ir-graph'!$S$34:$S$62</c:f>
                <c:numCache>
                  <c:formatCode>General</c:formatCode>
                  <c:ptCount val="29"/>
                  <c:pt idx="0">
                    <c:v>1.6777739108702532E-3</c:v>
                  </c:pt>
                  <c:pt idx="1">
                    <c:v>1.4833370877665093E-3</c:v>
                  </c:pt>
                  <c:pt idx="2">
                    <c:v>7.357099378464939E-4</c:v>
                  </c:pt>
                  <c:pt idx="3">
                    <c:v>9.7091165475615964E-4</c:v>
                  </c:pt>
                  <c:pt idx="4">
                    <c:v>7.5510959382738528E-4</c:v>
                  </c:pt>
                  <c:pt idx="5">
                    <c:v>1.294487849179915E-3</c:v>
                  </c:pt>
                  <c:pt idx="6">
                    <c:v>4.8714355652277599E-4</c:v>
                  </c:pt>
                  <c:pt idx="7">
                    <c:v>1.4067209128559945E-3</c:v>
                  </c:pt>
                  <c:pt idx="8">
                    <c:v>1.9947826153438536E-3</c:v>
                  </c:pt>
                  <c:pt idx="9">
                    <c:v>2.8385972344554668E-3</c:v>
                  </c:pt>
                  <c:pt idx="10">
                    <c:v>8.578808637094603E-3</c:v>
                  </c:pt>
                  <c:pt idx="11">
                    <c:v>4.0074504568776894E-3</c:v>
                  </c:pt>
                  <c:pt idx="12">
                    <c:v>6.2065179593434833E-4</c:v>
                  </c:pt>
                  <c:pt idx="13">
                    <c:v>5.1722659240194745E-4</c:v>
                  </c:pt>
                  <c:pt idx="14">
                    <c:v>5.2251499365874206E-4</c:v>
                  </c:pt>
                  <c:pt idx="15">
                    <c:v>4.2705226747191254E-4</c:v>
                  </c:pt>
                  <c:pt idx="16">
                    <c:v>1.4767252229657794E-3</c:v>
                  </c:pt>
                  <c:pt idx="17">
                    <c:v>5.558158971528522E-4</c:v>
                  </c:pt>
                  <c:pt idx="18">
                    <c:v>1.916239846323789E-3</c:v>
                  </c:pt>
                  <c:pt idx="19">
                    <c:v>1.4914429381416479E-3</c:v>
                  </c:pt>
                  <c:pt idx="20">
                    <c:v>7.2569003851184072E-4</c:v>
                  </c:pt>
                  <c:pt idx="21">
                    <c:v>2.4873114227435219E-3</c:v>
                  </c:pt>
                  <c:pt idx="22">
                    <c:v>3.3112483302533613E-3</c:v>
                  </c:pt>
                  <c:pt idx="23">
                    <c:v>9.4256110337291924E-4</c:v>
                  </c:pt>
                  <c:pt idx="24">
                    <c:v>1.0859986097876894E-3</c:v>
                  </c:pt>
                  <c:pt idx="25">
                    <c:v>7.1352286463597107E-4</c:v>
                  </c:pt>
                  <c:pt idx="26">
                    <c:v>2.1646548092578281E-3</c:v>
                  </c:pt>
                  <c:pt idx="27">
                    <c:v>1.9582084030540601E-3</c:v>
                  </c:pt>
                  <c:pt idx="28">
                    <c:v>1.557491446369466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air-graph'!$R$3:$R$31</c:f>
              <c:strCache>
                <c:ptCount val="29"/>
                <c:pt idx="0">
                  <c:v>Flagellar assembly</c:v>
                </c:pt>
                <c:pt idx="1">
                  <c:v>Bacterial chemotaxis</c:v>
                </c:pt>
                <c:pt idx="2">
                  <c:v>Cell cycle - Caulobacter</c:v>
                </c:pt>
                <c:pt idx="3">
                  <c:v>Mismatch repair</c:v>
                </c:pt>
                <c:pt idx="4">
                  <c:v>Nucleotide excision repair</c:v>
                </c:pt>
                <c:pt idx="5">
                  <c:v>Homologous recombination</c:v>
                </c:pt>
                <c:pt idx="6">
                  <c:v>RNA degradation</c:v>
                </c:pt>
                <c:pt idx="7">
                  <c:v>Ribosome</c:v>
                </c:pt>
                <c:pt idx="8">
                  <c:v>Aminoacyl-tRNA biosynthesis</c:v>
                </c:pt>
                <c:pt idx="9">
                  <c:v>Bacterial secretion system</c:v>
                </c:pt>
                <c:pt idx="10">
                  <c:v>Two-component system</c:v>
                </c:pt>
                <c:pt idx="11">
                  <c:v>ABC transporters</c:v>
                </c:pt>
                <c:pt idx="12">
                  <c:v>Cysteine and methionine metabolism</c:v>
                </c:pt>
                <c:pt idx="13">
                  <c:v>Phenylalanine, tyrosine and tryptophan biosynthesis</c:v>
                </c:pt>
                <c:pt idx="14">
                  <c:v>Alanine, aspartate and glutamate metabolism</c:v>
                </c:pt>
                <c:pt idx="15">
                  <c:v>Methane metabolism</c:v>
                </c:pt>
                <c:pt idx="16">
                  <c:v>Fructose and mannose metabolism</c:v>
                </c:pt>
                <c:pt idx="17">
                  <c:v>Pyruvate metabolism</c:v>
                </c:pt>
                <c:pt idx="18">
                  <c:v>Glyoxylate and dicarboxylate metabolism</c:v>
                </c:pt>
                <c:pt idx="19">
                  <c:v>Peptidoglycan biosynthesis</c:v>
                </c:pt>
                <c:pt idx="20">
                  <c:v>Glycine, serine and threonine metabolism</c:v>
                </c:pt>
                <c:pt idx="21">
                  <c:v>Amino sugar and nucleotide sugar metabolism</c:v>
                </c:pt>
                <c:pt idx="22">
                  <c:v>Starch and sucrose metabolism</c:v>
                </c:pt>
                <c:pt idx="23">
                  <c:v>Porphyrin and chlorophyll metabolism</c:v>
                </c:pt>
                <c:pt idx="24">
                  <c:v>Oxidative phosphorylation</c:v>
                </c:pt>
                <c:pt idx="25">
                  <c:v>Arginine and proline metabolism</c:v>
                </c:pt>
                <c:pt idx="26">
                  <c:v>Nitrogen metabolism</c:v>
                </c:pt>
                <c:pt idx="27">
                  <c:v>Pyrimidine metabolism</c:v>
                </c:pt>
                <c:pt idx="28">
                  <c:v>Purine metabolism</c:v>
                </c:pt>
              </c:strCache>
            </c:strRef>
          </c:cat>
          <c:val>
            <c:numRef>
              <c:f>'air-graph'!$S$3:$S$31</c:f>
              <c:numCache>
                <c:formatCode>General</c:formatCode>
                <c:ptCount val="29"/>
                <c:pt idx="0">
                  <c:v>1.1238678778304281E-2</c:v>
                </c:pt>
                <c:pt idx="1">
                  <c:v>1.1403637440505199E-2</c:v>
                </c:pt>
                <c:pt idx="2">
                  <c:v>1.3910926080455367E-2</c:v>
                </c:pt>
                <c:pt idx="3">
                  <c:v>9.0536931751740869E-3</c:v>
                </c:pt>
                <c:pt idx="4">
                  <c:v>1.0059264311063198E-2</c:v>
                </c:pt>
                <c:pt idx="5">
                  <c:v>1.1548604831317212E-2</c:v>
                </c:pt>
                <c:pt idx="6">
                  <c:v>1.2372506778580716E-2</c:v>
                </c:pt>
                <c:pt idx="7">
                  <c:v>1.5661907128323202E-2</c:v>
                </c:pt>
                <c:pt idx="8">
                  <c:v>2.6621980966038825E-2</c:v>
                </c:pt>
                <c:pt idx="9">
                  <c:v>1.9843313021840323E-2</c:v>
                </c:pt>
                <c:pt idx="10">
                  <c:v>8.0198787525747717E-2</c:v>
                </c:pt>
                <c:pt idx="11">
                  <c:v>9.3769286044832742E-2</c:v>
                </c:pt>
                <c:pt idx="12">
                  <c:v>1.0541223486783656E-2</c:v>
                </c:pt>
                <c:pt idx="13">
                  <c:v>1.0594800792949019E-2</c:v>
                </c:pt>
                <c:pt idx="14">
                  <c:v>1.0886620942400385E-2</c:v>
                </c:pt>
                <c:pt idx="15">
                  <c:v>1.194896184102788E-2</c:v>
                </c:pt>
                <c:pt idx="16">
                  <c:v>1.2478421383975206E-2</c:v>
                </c:pt>
                <c:pt idx="17">
                  <c:v>1.331520974905055E-2</c:v>
                </c:pt>
                <c:pt idx="18">
                  <c:v>1.37460703444809E-2</c:v>
                </c:pt>
                <c:pt idx="19">
                  <c:v>1.3963961985171001E-2</c:v>
                </c:pt>
                <c:pt idx="20">
                  <c:v>1.4704448731869661E-2</c:v>
                </c:pt>
                <c:pt idx="21">
                  <c:v>1.5434467673036797E-2</c:v>
                </c:pt>
                <c:pt idx="22">
                  <c:v>1.6569923924511436E-2</c:v>
                </c:pt>
                <c:pt idx="23">
                  <c:v>1.6907718373734643E-2</c:v>
                </c:pt>
                <c:pt idx="24">
                  <c:v>1.7405818385425847E-2</c:v>
                </c:pt>
                <c:pt idx="25">
                  <c:v>1.888227179768107E-2</c:v>
                </c:pt>
                <c:pt idx="26">
                  <c:v>2.0244549469728344E-2</c:v>
                </c:pt>
                <c:pt idx="27">
                  <c:v>2.0666016163077148E-2</c:v>
                </c:pt>
                <c:pt idx="28">
                  <c:v>3.2535954016993364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522-4721-9D35-AD32C7EF105F}"/>
            </c:ext>
          </c:extLst>
        </c:ser>
        <c:ser>
          <c:idx val="1"/>
          <c:order val="1"/>
          <c:tx>
            <c:strRef>
              <c:f>'air-graph'!$T$2</c:f>
              <c:strCache>
                <c:ptCount val="1"/>
                <c:pt idx="0">
                  <c:v>AE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ir-graph'!$T$34:$T$62</c:f>
                <c:numCache>
                  <c:formatCode>General</c:formatCode>
                  <c:ptCount val="29"/>
                  <c:pt idx="0">
                    <c:v>2.2095659672935752E-3</c:v>
                  </c:pt>
                  <c:pt idx="1">
                    <c:v>1.680913453229348E-3</c:v>
                  </c:pt>
                  <c:pt idx="2">
                    <c:v>1.3437898476905661E-3</c:v>
                  </c:pt>
                  <c:pt idx="3">
                    <c:v>1.2379528227169784E-3</c:v>
                  </c:pt>
                  <c:pt idx="4">
                    <c:v>1.041265662458671E-3</c:v>
                  </c:pt>
                  <c:pt idx="5">
                    <c:v>2.3082311277191733E-3</c:v>
                  </c:pt>
                  <c:pt idx="6">
                    <c:v>1.1892092778224995E-3</c:v>
                  </c:pt>
                  <c:pt idx="7">
                    <c:v>2.107472791747131E-3</c:v>
                  </c:pt>
                  <c:pt idx="8">
                    <c:v>2.1699761088930761E-3</c:v>
                  </c:pt>
                  <c:pt idx="9">
                    <c:v>1.6964037563589073E-3</c:v>
                  </c:pt>
                  <c:pt idx="10">
                    <c:v>4.3466591030883817E-3</c:v>
                  </c:pt>
                  <c:pt idx="11">
                    <c:v>1.3351762658471662E-2</c:v>
                  </c:pt>
                  <c:pt idx="12">
                    <c:v>4.1253651486548528E-4</c:v>
                  </c:pt>
                  <c:pt idx="13">
                    <c:v>9.9590760361952684E-4</c:v>
                  </c:pt>
                  <c:pt idx="14">
                    <c:v>3.1813889040851529E-3</c:v>
                  </c:pt>
                  <c:pt idx="15">
                    <c:v>8.4017099373526953E-4</c:v>
                  </c:pt>
                  <c:pt idx="16">
                    <c:v>2.5294354887131589E-3</c:v>
                  </c:pt>
                  <c:pt idx="17">
                    <c:v>8.5884232554047626E-4</c:v>
                  </c:pt>
                  <c:pt idx="18">
                    <c:v>2.5340034629355306E-3</c:v>
                  </c:pt>
                  <c:pt idx="19">
                    <c:v>1.4775818536275104E-3</c:v>
                  </c:pt>
                  <c:pt idx="20">
                    <c:v>1.3142194757126782E-3</c:v>
                  </c:pt>
                  <c:pt idx="21">
                    <c:v>4.4817778850420962E-3</c:v>
                  </c:pt>
                  <c:pt idx="22">
                    <c:v>4.7624317854457086E-3</c:v>
                  </c:pt>
                  <c:pt idx="23">
                    <c:v>1.881498056639314E-3</c:v>
                  </c:pt>
                  <c:pt idx="24">
                    <c:v>1.4995947913549453E-3</c:v>
                  </c:pt>
                  <c:pt idx="25">
                    <c:v>2.9884652872357886E-3</c:v>
                  </c:pt>
                  <c:pt idx="26">
                    <c:v>2.1665870176338252E-3</c:v>
                  </c:pt>
                  <c:pt idx="27">
                    <c:v>4.6223483019828641E-3</c:v>
                  </c:pt>
                  <c:pt idx="28">
                    <c:v>1.1356771633610405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air-graph'!$R$3:$R$31</c:f>
              <c:strCache>
                <c:ptCount val="29"/>
                <c:pt idx="0">
                  <c:v>Flagellar assembly</c:v>
                </c:pt>
                <c:pt idx="1">
                  <c:v>Bacterial chemotaxis</c:v>
                </c:pt>
                <c:pt idx="2">
                  <c:v>Cell cycle - Caulobacter</c:v>
                </c:pt>
                <c:pt idx="3">
                  <c:v>Mismatch repair</c:v>
                </c:pt>
                <c:pt idx="4">
                  <c:v>Nucleotide excision repair</c:v>
                </c:pt>
                <c:pt idx="5">
                  <c:v>Homologous recombination</c:v>
                </c:pt>
                <c:pt idx="6">
                  <c:v>RNA degradation</c:v>
                </c:pt>
                <c:pt idx="7">
                  <c:v>Ribosome</c:v>
                </c:pt>
                <c:pt idx="8">
                  <c:v>Aminoacyl-tRNA biosynthesis</c:v>
                </c:pt>
                <c:pt idx="9">
                  <c:v>Bacterial secretion system</c:v>
                </c:pt>
                <c:pt idx="10">
                  <c:v>Two-component system</c:v>
                </c:pt>
                <c:pt idx="11">
                  <c:v>ABC transporters</c:v>
                </c:pt>
                <c:pt idx="12">
                  <c:v>Cysteine and methionine metabolism</c:v>
                </c:pt>
                <c:pt idx="13">
                  <c:v>Phenylalanine, tyrosine and tryptophan biosynthesis</c:v>
                </c:pt>
                <c:pt idx="14">
                  <c:v>Alanine, aspartate and glutamate metabolism</c:v>
                </c:pt>
                <c:pt idx="15">
                  <c:v>Methane metabolism</c:v>
                </c:pt>
                <c:pt idx="16">
                  <c:v>Fructose and mannose metabolism</c:v>
                </c:pt>
                <c:pt idx="17">
                  <c:v>Pyruvate metabolism</c:v>
                </c:pt>
                <c:pt idx="18">
                  <c:v>Glyoxylate and dicarboxylate metabolism</c:v>
                </c:pt>
                <c:pt idx="19">
                  <c:v>Peptidoglycan biosynthesis</c:v>
                </c:pt>
                <c:pt idx="20">
                  <c:v>Glycine, serine and threonine metabolism</c:v>
                </c:pt>
                <c:pt idx="21">
                  <c:v>Amino sugar and nucleotide sugar metabolism</c:v>
                </c:pt>
                <c:pt idx="22">
                  <c:v>Starch and sucrose metabolism</c:v>
                </c:pt>
                <c:pt idx="23">
                  <c:v>Porphyrin and chlorophyll metabolism</c:v>
                </c:pt>
                <c:pt idx="24">
                  <c:v>Oxidative phosphorylation</c:v>
                </c:pt>
                <c:pt idx="25">
                  <c:v>Arginine and proline metabolism</c:v>
                </c:pt>
                <c:pt idx="26">
                  <c:v>Nitrogen metabolism</c:v>
                </c:pt>
                <c:pt idx="27">
                  <c:v>Pyrimidine metabolism</c:v>
                </c:pt>
                <c:pt idx="28">
                  <c:v>Purine metabolism</c:v>
                </c:pt>
              </c:strCache>
            </c:strRef>
          </c:cat>
          <c:val>
            <c:numRef>
              <c:f>'air-graph'!$T$3:$T$31</c:f>
              <c:numCache>
                <c:formatCode>General</c:formatCode>
                <c:ptCount val="29"/>
                <c:pt idx="0">
                  <c:v>8.3807059854962736E-3</c:v>
                </c:pt>
                <c:pt idx="1">
                  <c:v>9.0702167241453555E-3</c:v>
                </c:pt>
                <c:pt idx="2">
                  <c:v>1.4248734358358316E-2</c:v>
                </c:pt>
                <c:pt idx="3">
                  <c:v>1.0860147709295311E-2</c:v>
                </c:pt>
                <c:pt idx="4">
                  <c:v>1.122313041285814E-2</c:v>
                </c:pt>
                <c:pt idx="5">
                  <c:v>1.4348681417328266E-2</c:v>
                </c:pt>
                <c:pt idx="6">
                  <c:v>1.3313119359799239E-2</c:v>
                </c:pt>
                <c:pt idx="7">
                  <c:v>1.8795893227978037E-2</c:v>
                </c:pt>
                <c:pt idx="8">
                  <c:v>3.0229268994756666E-2</c:v>
                </c:pt>
                <c:pt idx="9">
                  <c:v>1.4608200846903008E-2</c:v>
                </c:pt>
                <c:pt idx="10">
                  <c:v>6.732594601228388E-2</c:v>
                </c:pt>
                <c:pt idx="11">
                  <c:v>9.1821051320826935E-2</c:v>
                </c:pt>
                <c:pt idx="12">
                  <c:v>1.1284046959953949E-2</c:v>
                </c:pt>
                <c:pt idx="13">
                  <c:v>1.1518963610471075E-2</c:v>
                </c:pt>
                <c:pt idx="14">
                  <c:v>1.3413545950650458E-2</c:v>
                </c:pt>
                <c:pt idx="15">
                  <c:v>1.2747514778676645E-2</c:v>
                </c:pt>
                <c:pt idx="16">
                  <c:v>1.6142539058029079E-2</c:v>
                </c:pt>
                <c:pt idx="17">
                  <c:v>1.2252497562257299E-2</c:v>
                </c:pt>
                <c:pt idx="18">
                  <c:v>9.9957265152832986E-3</c:v>
                </c:pt>
                <c:pt idx="19">
                  <c:v>1.6026270031493914E-2</c:v>
                </c:pt>
                <c:pt idx="20">
                  <c:v>1.3809469443278384E-2</c:v>
                </c:pt>
                <c:pt idx="21">
                  <c:v>2.1434026930671347E-2</c:v>
                </c:pt>
                <c:pt idx="22">
                  <c:v>2.2871279750023808E-2</c:v>
                </c:pt>
                <c:pt idx="23">
                  <c:v>1.6388931121865E-2</c:v>
                </c:pt>
                <c:pt idx="24">
                  <c:v>1.6506734236853834E-2</c:v>
                </c:pt>
                <c:pt idx="25">
                  <c:v>2.0367811651020241E-2</c:v>
                </c:pt>
                <c:pt idx="26">
                  <c:v>1.6590983215709027E-2</c:v>
                </c:pt>
                <c:pt idx="27">
                  <c:v>2.6060741499609741E-2</c:v>
                </c:pt>
                <c:pt idx="28">
                  <c:v>3.460200001709572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522-4721-9D35-AD32C7EF105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1033608656"/>
        <c:axId val="1033607952"/>
      </c:barChart>
      <c:catAx>
        <c:axId val="103360865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1033607952"/>
        <c:crosses val="autoZero"/>
        <c:auto val="1"/>
        <c:lblAlgn val="ctr"/>
        <c:lblOffset val="100"/>
        <c:noMultiLvlLbl val="0"/>
      </c:catAx>
      <c:valAx>
        <c:axId val="103360795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Relative abundace</a:t>
                </a:r>
                <a:endParaRPr lang="ko-KR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ko-K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10336086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r"/>
      <c:layout>
        <c:manualLayout>
          <c:xMode val="edge"/>
          <c:yMode val="edge"/>
          <c:x val="0.78017591634825811"/>
          <c:y val="4.4585987261146494E-2"/>
          <c:w val="0.15548092011286793"/>
          <c:h val="4.6178845478710068E-2"/>
        </c:manualLayout>
      </c:layout>
      <c:overlay val="1"/>
      <c:spPr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'soil-graph'!$Z$2</c:f>
              <c:strCache>
                <c:ptCount val="1"/>
                <c:pt idx="0">
                  <c:v>SB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soil-graph'!$Z$22:$Z$38</c:f>
                <c:numCache>
                  <c:formatCode>General</c:formatCode>
                  <c:ptCount val="17"/>
                  <c:pt idx="0">
                    <c:v>3.0667798655426896E-3</c:v>
                  </c:pt>
                  <c:pt idx="1">
                    <c:v>2.8523482063932573E-3</c:v>
                  </c:pt>
                  <c:pt idx="2">
                    <c:v>7.6086794786212643E-3</c:v>
                  </c:pt>
                  <c:pt idx="3">
                    <c:v>8.820233365972114E-3</c:v>
                  </c:pt>
                  <c:pt idx="4">
                    <c:v>8.7241785209803743E-4</c:v>
                  </c:pt>
                  <c:pt idx="5">
                    <c:v>9.0588652318743875E-4</c:v>
                  </c:pt>
                  <c:pt idx="6">
                    <c:v>6.1196078857844358E-4</c:v>
                  </c:pt>
                  <c:pt idx="7">
                    <c:v>1.1323885590412482E-3</c:v>
                  </c:pt>
                  <c:pt idx="8">
                    <c:v>5.4236746309678648E-4</c:v>
                  </c:pt>
                  <c:pt idx="9">
                    <c:v>5.9949432073304386E-4</c:v>
                  </c:pt>
                  <c:pt idx="10">
                    <c:v>1.2695069211822499E-3</c:v>
                  </c:pt>
                  <c:pt idx="11">
                    <c:v>9.7593435011087207E-4</c:v>
                  </c:pt>
                  <c:pt idx="12">
                    <c:v>1.7116378783721433E-3</c:v>
                  </c:pt>
                  <c:pt idx="13">
                    <c:v>2.5167398342533457E-3</c:v>
                  </c:pt>
                  <c:pt idx="14">
                    <c:v>2.4722329197339418E-3</c:v>
                  </c:pt>
                  <c:pt idx="15">
                    <c:v>4.3735281514406471E-3</c:v>
                  </c:pt>
                  <c:pt idx="16">
                    <c:v>3.4054789757228493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oil-graph'!$Y$3:$Y$19</c:f>
              <c:strCache>
                <c:ptCount val="17"/>
                <c:pt idx="0">
                  <c:v>Quorum sensing</c:v>
                </c:pt>
                <c:pt idx="1">
                  <c:v>Phosphotransferase system (PTS)</c:v>
                </c:pt>
                <c:pt idx="2">
                  <c:v>Two-component system</c:v>
                </c:pt>
                <c:pt idx="3">
                  <c:v>ABC transporters</c:v>
                </c:pt>
                <c:pt idx="4">
                  <c:v>Glycolysis / Gluconeogenesis</c:v>
                </c:pt>
                <c:pt idx="5">
                  <c:v>Amino sugar and nucleotide sugar metabolism</c:v>
                </c:pt>
                <c:pt idx="6">
                  <c:v>Butanoate metabolism</c:v>
                </c:pt>
                <c:pt idx="7">
                  <c:v>Valine, leucine and isoleucine degradation</c:v>
                </c:pt>
                <c:pt idx="8">
                  <c:v>Pyruvate metabolism</c:v>
                </c:pt>
                <c:pt idx="9">
                  <c:v>Purine metabolism</c:v>
                </c:pt>
                <c:pt idx="10">
                  <c:v>Fatty acid metabolism</c:v>
                </c:pt>
                <c:pt idx="11">
                  <c:v>Biosynthesis of amino acids</c:v>
                </c:pt>
                <c:pt idx="12">
                  <c:v>Carbon metabolism</c:v>
                </c:pt>
                <c:pt idx="13">
                  <c:v>Biosynthesis of antibiotics</c:v>
                </c:pt>
                <c:pt idx="14">
                  <c:v>Biosynthesis of secondary metabolites</c:v>
                </c:pt>
                <c:pt idx="15">
                  <c:v>Microbial metabolism in diverse environments</c:v>
                </c:pt>
                <c:pt idx="16">
                  <c:v>Metabolic pathways</c:v>
                </c:pt>
              </c:strCache>
            </c:strRef>
          </c:cat>
          <c:val>
            <c:numRef>
              <c:f>'soil-graph'!$Z$3:$Z$19</c:f>
              <c:numCache>
                <c:formatCode>General</c:formatCode>
                <c:ptCount val="17"/>
                <c:pt idx="0">
                  <c:v>2.5523935886752364E-2</c:v>
                </c:pt>
                <c:pt idx="1">
                  <c:v>3.3249528792371188E-3</c:v>
                </c:pt>
                <c:pt idx="2">
                  <c:v>4.8547636338371426E-2</c:v>
                </c:pt>
                <c:pt idx="3">
                  <c:v>4.6199498363206928E-2</c:v>
                </c:pt>
                <c:pt idx="4">
                  <c:v>8.9101384118772092E-3</c:v>
                </c:pt>
                <c:pt idx="5">
                  <c:v>7.9728526791766341E-3</c:v>
                </c:pt>
                <c:pt idx="6">
                  <c:v>1.0287701425854043E-2</c:v>
                </c:pt>
                <c:pt idx="7">
                  <c:v>1.1028483901565312E-2</c:v>
                </c:pt>
                <c:pt idx="8">
                  <c:v>1.1113565202935206E-2</c:v>
                </c:pt>
                <c:pt idx="9">
                  <c:v>1.121779844899912E-2</c:v>
                </c:pt>
                <c:pt idx="10">
                  <c:v>1.2960185120724969E-2</c:v>
                </c:pt>
                <c:pt idx="11">
                  <c:v>2.1090217524626139E-2</c:v>
                </c:pt>
                <c:pt idx="12">
                  <c:v>2.4299164059852208E-2</c:v>
                </c:pt>
                <c:pt idx="13">
                  <c:v>4.8250793843837597E-2</c:v>
                </c:pt>
                <c:pt idx="14">
                  <c:v>5.4701824442044918E-2</c:v>
                </c:pt>
                <c:pt idx="15">
                  <c:v>5.8032661039346185E-2</c:v>
                </c:pt>
                <c:pt idx="16">
                  <c:v>0.133191863229687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8FD-4DEA-9783-1B8B99340B24}"/>
            </c:ext>
          </c:extLst>
        </c:ser>
        <c:ser>
          <c:idx val="1"/>
          <c:order val="1"/>
          <c:tx>
            <c:strRef>
              <c:f>'soil-graph'!$AA$2</c:f>
              <c:strCache>
                <c:ptCount val="1"/>
                <c:pt idx="0">
                  <c:v>SE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soil-graph'!$AA$22:$AA$38</c:f>
                <c:numCache>
                  <c:formatCode>General</c:formatCode>
                  <c:ptCount val="17"/>
                  <c:pt idx="0">
                    <c:v>1.5105391011528766E-3</c:v>
                  </c:pt>
                  <c:pt idx="1">
                    <c:v>7.6730250973183391E-3</c:v>
                  </c:pt>
                  <c:pt idx="2">
                    <c:v>5.3150257932793928E-3</c:v>
                  </c:pt>
                  <c:pt idx="3">
                    <c:v>4.2933901541662017E-3</c:v>
                  </c:pt>
                  <c:pt idx="4">
                    <c:v>1.5544880794843077E-3</c:v>
                  </c:pt>
                  <c:pt idx="5">
                    <c:v>3.1688367247326241E-3</c:v>
                  </c:pt>
                  <c:pt idx="6">
                    <c:v>8.3414327146994361E-4</c:v>
                  </c:pt>
                  <c:pt idx="7">
                    <c:v>2.6517927368017789E-3</c:v>
                  </c:pt>
                  <c:pt idx="8">
                    <c:v>4.1030157538881094E-4</c:v>
                  </c:pt>
                  <c:pt idx="9">
                    <c:v>1.7131428124124053E-3</c:v>
                  </c:pt>
                  <c:pt idx="10">
                    <c:v>2.0066020381943684E-3</c:v>
                  </c:pt>
                  <c:pt idx="11">
                    <c:v>1.3609890325369054E-3</c:v>
                  </c:pt>
                  <c:pt idx="12">
                    <c:v>1.0808757047796223E-3</c:v>
                  </c:pt>
                  <c:pt idx="13">
                    <c:v>2.3228944263388278E-3</c:v>
                  </c:pt>
                  <c:pt idx="14">
                    <c:v>2.3270182006668596E-3</c:v>
                  </c:pt>
                  <c:pt idx="15">
                    <c:v>3.906738984720064E-3</c:v>
                  </c:pt>
                  <c:pt idx="16">
                    <c:v>3.4124471569495348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oil-graph'!$Y$3:$Y$19</c:f>
              <c:strCache>
                <c:ptCount val="17"/>
                <c:pt idx="0">
                  <c:v>Quorum sensing</c:v>
                </c:pt>
                <c:pt idx="1">
                  <c:v>Phosphotransferase system (PTS)</c:v>
                </c:pt>
                <c:pt idx="2">
                  <c:v>Two-component system</c:v>
                </c:pt>
                <c:pt idx="3">
                  <c:v>ABC transporters</c:v>
                </c:pt>
                <c:pt idx="4">
                  <c:v>Glycolysis / Gluconeogenesis</c:v>
                </c:pt>
                <c:pt idx="5">
                  <c:v>Amino sugar and nucleotide sugar metabolism</c:v>
                </c:pt>
                <c:pt idx="6">
                  <c:v>Butanoate metabolism</c:v>
                </c:pt>
                <c:pt idx="7">
                  <c:v>Valine, leucine and isoleucine degradation</c:v>
                </c:pt>
                <c:pt idx="8">
                  <c:v>Pyruvate metabolism</c:v>
                </c:pt>
                <c:pt idx="9">
                  <c:v>Purine metabolism</c:v>
                </c:pt>
                <c:pt idx="10">
                  <c:v>Fatty acid metabolism</c:v>
                </c:pt>
                <c:pt idx="11">
                  <c:v>Biosynthesis of amino acids</c:v>
                </c:pt>
                <c:pt idx="12">
                  <c:v>Carbon metabolism</c:v>
                </c:pt>
                <c:pt idx="13">
                  <c:v>Biosynthesis of antibiotics</c:v>
                </c:pt>
                <c:pt idx="14">
                  <c:v>Biosynthesis of secondary metabolites</c:v>
                </c:pt>
                <c:pt idx="15">
                  <c:v>Microbial metabolism in diverse environments</c:v>
                </c:pt>
                <c:pt idx="16">
                  <c:v>Metabolic pathways</c:v>
                </c:pt>
              </c:strCache>
            </c:strRef>
          </c:cat>
          <c:val>
            <c:numRef>
              <c:f>'soil-graph'!$AA$3:$AA$19</c:f>
              <c:numCache>
                <c:formatCode>General</c:formatCode>
                <c:ptCount val="17"/>
                <c:pt idx="0">
                  <c:v>2.4972819166986879E-2</c:v>
                </c:pt>
                <c:pt idx="1">
                  <c:v>1.4839625810820241E-2</c:v>
                </c:pt>
                <c:pt idx="2">
                  <c:v>3.9715668573027725E-2</c:v>
                </c:pt>
                <c:pt idx="3">
                  <c:v>5.5013745400848087E-2</c:v>
                </c:pt>
                <c:pt idx="4">
                  <c:v>1.2005808084069642E-2</c:v>
                </c:pt>
                <c:pt idx="5">
                  <c:v>1.2763099333839846E-2</c:v>
                </c:pt>
                <c:pt idx="6">
                  <c:v>9.0003195675023052E-3</c:v>
                </c:pt>
                <c:pt idx="7">
                  <c:v>7.3773936803204314E-3</c:v>
                </c:pt>
                <c:pt idx="8">
                  <c:v>1.1892479953757107E-2</c:v>
                </c:pt>
                <c:pt idx="9">
                  <c:v>1.3864863313785409E-2</c:v>
                </c:pt>
                <c:pt idx="10">
                  <c:v>9.0296814067492882E-3</c:v>
                </c:pt>
                <c:pt idx="11">
                  <c:v>2.3270466805792256E-2</c:v>
                </c:pt>
                <c:pt idx="12">
                  <c:v>2.4923241617563541E-2</c:v>
                </c:pt>
                <c:pt idx="13">
                  <c:v>4.7357573073932901E-2</c:v>
                </c:pt>
                <c:pt idx="14">
                  <c:v>5.7243757048950877E-2</c:v>
                </c:pt>
                <c:pt idx="15">
                  <c:v>5.4903818026165736E-2</c:v>
                </c:pt>
                <c:pt idx="16">
                  <c:v>0.137656461088344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8FD-4DEA-9783-1B8B99340B2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220421232"/>
        <c:axId val="220415000"/>
      </c:barChart>
      <c:catAx>
        <c:axId val="22042123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220415000"/>
        <c:crosses val="autoZero"/>
        <c:auto val="1"/>
        <c:lblAlgn val="ctr"/>
        <c:lblOffset val="100"/>
        <c:noMultiLvlLbl val="0"/>
      </c:catAx>
      <c:valAx>
        <c:axId val="22041500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ko-KR"/>
                  <a:t>Relative abundance</a:t>
                </a:r>
                <a:endParaRPr lang="ko-KR" alt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ko-KR" alt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22042123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r"/>
      <c:layout>
        <c:manualLayout>
          <c:xMode val="edge"/>
          <c:yMode val="edge"/>
          <c:x val="0.81968235327704775"/>
          <c:y val="0.10265688434986572"/>
          <c:w val="0.13216540227272477"/>
          <c:h val="6.1805467778117205E-2"/>
        </c:manualLayout>
      </c:layout>
      <c:overlay val="1"/>
      <c:spPr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dk1"/>
              </a:solidFill>
              <a:latin typeface="+mn-lt"/>
              <a:ea typeface="+mn-ea"/>
              <a:cs typeface="+mn-cs"/>
            </a:defRPr>
          </a:pPr>
          <a:endParaRPr lang="ko-K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6539142-D700-994C-A881-2F83CBF1E36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D0B609C9-9D6F-3140-BACC-62342CD3997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D865CE8-A1B2-DF42-AD2C-FB6F504703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BC32C-69BB-D44F-9226-ECFD85FF2785}" type="datetimeFigureOut">
              <a:rPr kumimoji="1" lang="ko-KR" altLang="en-US" smtClean="0"/>
              <a:t>2025-03-02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315B027-D345-D348-83D0-A854B4BE03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B9A9FAF-4601-144B-9600-6526EC9425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D0A96-FE87-934B-8F74-128B0FB2BADA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24584918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C5D06C2-9250-184C-9C5C-6472C100B2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886A49DF-C4BD-6743-A64A-FC380EFCE1E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CDA8940-7D12-E349-AC1E-72F37505C4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BC32C-69BB-D44F-9226-ECFD85FF2785}" type="datetimeFigureOut">
              <a:rPr kumimoji="1" lang="ko-KR" altLang="en-US" smtClean="0"/>
              <a:t>2025-03-02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C316056-AD54-6640-ABFE-7557602F5E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6666D7E-DA06-0547-8E5D-6FC3908406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D0A96-FE87-934B-8F74-128B0FB2BADA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34685526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91154AFF-965C-D04A-88FF-D9A41ABA4A5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DC5C0C01-8AE4-D444-9FA1-FFA3E7867B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D9937DE-C0E8-6B4E-AC02-ED4B932162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BC32C-69BB-D44F-9226-ECFD85FF2785}" type="datetimeFigureOut">
              <a:rPr kumimoji="1" lang="ko-KR" altLang="en-US" smtClean="0"/>
              <a:t>2025-03-02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3B61F67-BB2D-6946-867B-D44EF4E27D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BE43365-4E8E-1044-92B3-B15C8A7DA3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D0A96-FE87-934B-8F74-128B0FB2BADA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22841625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6BB97C6-78BF-E54B-8D40-59A1C11EF2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6148553A-BB27-D148-B4D2-1F792CE0AC3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91E9F3A-68E9-6849-9AC7-B6069E22FC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BC32C-69BB-D44F-9226-ECFD85FF2785}" type="datetimeFigureOut">
              <a:rPr kumimoji="1" lang="ko-KR" altLang="en-US" smtClean="0"/>
              <a:t>2025-03-02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BCE0A25-AFF4-CB4A-98A6-2290D8EF33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FB920C9-1DD3-D24A-819F-BA63FBEF6E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D0A96-FE87-934B-8F74-128B0FB2BADA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7180209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E159F83-7F70-1748-9570-5D1052B9AD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56D916C-CA3B-1742-9693-2BFB545057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3D88949-F5E1-A545-B8AE-7BF7878654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BC32C-69BB-D44F-9226-ECFD85FF2785}" type="datetimeFigureOut">
              <a:rPr kumimoji="1" lang="ko-KR" altLang="en-US" smtClean="0"/>
              <a:t>2025-03-02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8A44757-11A7-1A46-933B-C3694D1C59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5E7D94A-BCBF-4840-BF78-28FD668713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D0A96-FE87-934B-8F74-128B0FB2BADA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19711680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F83F531-231D-F348-B7A6-985B7C3B3D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D6CBF89-2EA8-1647-9453-556E107FBDE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403A56D1-AC11-824E-A391-8262751284C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D223AE85-2D0D-4247-8428-547FA632F9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BC32C-69BB-D44F-9226-ECFD85FF2785}" type="datetimeFigureOut">
              <a:rPr kumimoji="1" lang="ko-KR" altLang="en-US" smtClean="0"/>
              <a:t>2025-03-02</a:t>
            </a:fld>
            <a:endParaRPr kumimoji="1"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960AB0A-C9F7-D644-9061-9CFB060C63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262D5CF-5A7F-7D4A-8DD3-2D6D0AAB8A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D0A96-FE87-934B-8F74-128B0FB2BADA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32899827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B92C1DA-4F8A-5342-82FD-29AEBC031E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93EF963E-2603-A14D-9707-DA0AC93AAC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EE7F900F-E6DB-C94F-8E2C-AEA868BA16A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A7E5A12B-E758-E84C-9641-A76C8DB0ED5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9C0BF3C1-4EFA-E545-968E-728953F4AAE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CBC5504D-5584-654E-AFAA-18131AC7A7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BC32C-69BB-D44F-9226-ECFD85FF2785}" type="datetimeFigureOut">
              <a:rPr kumimoji="1" lang="ko-KR" altLang="en-US" smtClean="0"/>
              <a:t>2025-03-02</a:t>
            </a:fld>
            <a:endParaRPr kumimoji="1"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8AB6A627-FEF4-DE4A-A440-DC28710661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1B0C552E-19F8-B04E-9CDF-AD1F3311B8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D0A96-FE87-934B-8F74-128B0FB2BADA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15699655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C459705-B599-934E-9F02-E1AA821C70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02DCA441-4676-514E-8F89-A6B9C3EE3F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BC32C-69BB-D44F-9226-ECFD85FF2785}" type="datetimeFigureOut">
              <a:rPr kumimoji="1" lang="ko-KR" altLang="en-US" smtClean="0"/>
              <a:t>2025-03-02</a:t>
            </a:fld>
            <a:endParaRPr kumimoji="1"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F95F6CA9-9BB0-1747-9110-3F581DBE8F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B3A64443-6611-B246-A8D8-8B92476D43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D0A96-FE87-934B-8F74-128B0FB2BADA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27891119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956D0FEF-2E36-2A46-8D68-58E3797008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BC32C-69BB-D44F-9226-ECFD85FF2785}" type="datetimeFigureOut">
              <a:rPr kumimoji="1" lang="ko-KR" altLang="en-US" smtClean="0"/>
              <a:t>2025-03-02</a:t>
            </a:fld>
            <a:endParaRPr kumimoji="1"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176BC647-70F1-104F-B788-58FB0F99FC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A1C3DD9C-BE60-DE41-B029-4490B6D2A7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D0A96-FE87-934B-8F74-128B0FB2BADA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34750203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AD2FB27-E315-DD4E-A103-F546837808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2DF5FFED-72AC-404D-9FAD-87724D3D997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804B7DFB-66DF-1147-8E65-7BD04672B9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F4F4AEB-A64F-244B-AE0A-3EAAB8D256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BC32C-69BB-D44F-9226-ECFD85FF2785}" type="datetimeFigureOut">
              <a:rPr kumimoji="1" lang="ko-KR" altLang="en-US" smtClean="0"/>
              <a:t>2025-03-02</a:t>
            </a:fld>
            <a:endParaRPr kumimoji="1"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26AD90FD-C620-8C4D-B133-A214B8E96E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56FDBBC8-4074-E746-BDB2-5DC2F4896A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D0A96-FE87-934B-8F74-128B0FB2BADA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28305522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7461495-79B6-754A-A07D-C9A6D59FFA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997B85C3-0AF1-CA41-AD3B-825701AF564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618ECEB2-DF23-254D-9F7A-BD523F1F22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5F91A2F-14FA-EA44-9117-D920CC6216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BC32C-69BB-D44F-9226-ECFD85FF2785}" type="datetimeFigureOut">
              <a:rPr kumimoji="1" lang="ko-KR" altLang="en-US" smtClean="0"/>
              <a:t>2025-03-02</a:t>
            </a:fld>
            <a:endParaRPr kumimoji="1"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3E453E77-61D8-4847-8C10-DA877E65EE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5024122E-6917-F945-80EB-DBC72046E3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D0A96-FE87-934B-8F74-128B0FB2BADA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28210453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52EC5883-1BCA-9449-9A71-BC494581E4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274A446-969F-1442-A68B-9994802BEC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806424B-2689-B046-AED7-963338515A2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BBC32C-69BB-D44F-9226-ECFD85FF2785}" type="datetimeFigureOut">
              <a:rPr kumimoji="1" lang="ko-KR" altLang="en-US" smtClean="0"/>
              <a:t>2025-03-02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778031A-BBE8-F04A-9326-6838C22432A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C059A16-0816-924A-8FF7-09696FC1CCB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2D0A96-FE87-934B-8F74-128B0FB2BADA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41217622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D36442AD-FD5C-409F-B519-EA826162DDCE}"/>
              </a:ext>
            </a:extLst>
          </p:cNvPr>
          <p:cNvSpPr txBox="1"/>
          <p:nvPr/>
        </p:nvSpPr>
        <p:spPr>
          <a:xfrm>
            <a:off x="276942" y="243159"/>
            <a:ext cx="78916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b="1" dirty="0"/>
              <a:t>Fig. S1. Dominant functional pathway of bacteria and BEVs in (A) air and (B) soil.</a:t>
            </a:r>
          </a:p>
        </p:txBody>
      </p:sp>
      <p:graphicFrame>
        <p:nvGraphicFramePr>
          <p:cNvPr id="8" name="차트 7">
            <a:extLst>
              <a:ext uri="{FF2B5EF4-FFF2-40B4-BE49-F238E27FC236}">
                <a16:creationId xmlns:a16="http://schemas.microsoft.com/office/drawing/2014/main" id="{5B906568-C4A5-0E4E-99CF-16C8F452225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15307144"/>
              </p:ext>
            </p:extLst>
          </p:nvPr>
        </p:nvGraphicFramePr>
        <p:xfrm>
          <a:off x="1923743" y="876300"/>
          <a:ext cx="7105650" cy="58536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" name="표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98717660"/>
              </p:ext>
            </p:extLst>
          </p:nvPr>
        </p:nvGraphicFramePr>
        <p:xfrm>
          <a:off x="276942" y="1090506"/>
          <a:ext cx="1514065" cy="296028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14065">
                  <a:extLst>
                    <a:ext uri="{9D8B030D-6E8A-4147-A177-3AD203B41FA5}">
                      <a16:colId xmlns:a16="http://schemas.microsoft.com/office/drawing/2014/main" val="3845277698"/>
                    </a:ext>
                  </a:extLst>
                </a:gridCol>
              </a:tblGrid>
              <a:tr h="2960286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abolism</a:t>
                      </a:r>
                      <a:endParaRPr lang="ko-KR" alt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03158120"/>
                  </a:ext>
                </a:extLst>
              </a:tr>
            </a:tbl>
          </a:graphicData>
        </a:graphic>
      </p:graphicFrame>
      <p:graphicFrame>
        <p:nvGraphicFramePr>
          <p:cNvPr id="9" name="표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9033482"/>
              </p:ext>
            </p:extLst>
          </p:nvPr>
        </p:nvGraphicFramePr>
        <p:xfrm>
          <a:off x="276942" y="4142231"/>
          <a:ext cx="1514065" cy="40233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14065">
                  <a:extLst>
                    <a:ext uri="{9D8B030D-6E8A-4147-A177-3AD203B41FA5}">
                      <a16:colId xmlns:a16="http://schemas.microsoft.com/office/drawing/2014/main" val="3845277698"/>
                    </a:ext>
                  </a:extLst>
                </a:gridCol>
              </a:tblGrid>
              <a:tr h="402335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vironmental</a:t>
                      </a:r>
                      <a:r>
                        <a:rPr lang="en-US" altLang="ko-KR" sz="10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formation Processing</a:t>
                      </a:r>
                      <a:endParaRPr lang="ko-KR" alt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03158120"/>
                  </a:ext>
                </a:extLst>
              </a:tr>
            </a:tbl>
          </a:graphicData>
        </a:graphic>
      </p:graphicFrame>
      <p:graphicFrame>
        <p:nvGraphicFramePr>
          <p:cNvPr id="10" name="표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26521433"/>
              </p:ext>
            </p:extLst>
          </p:nvPr>
        </p:nvGraphicFramePr>
        <p:xfrm>
          <a:off x="276942" y="4617720"/>
          <a:ext cx="1514065" cy="97840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14065">
                  <a:extLst>
                    <a:ext uri="{9D8B030D-6E8A-4147-A177-3AD203B41FA5}">
                      <a16:colId xmlns:a16="http://schemas.microsoft.com/office/drawing/2014/main" val="3845277698"/>
                    </a:ext>
                  </a:extLst>
                </a:gridCol>
              </a:tblGrid>
              <a:tr h="978409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tic Information Processing</a:t>
                      </a:r>
                      <a:endParaRPr lang="ko-KR" alt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03158120"/>
                  </a:ext>
                </a:extLst>
              </a:tr>
            </a:tbl>
          </a:graphicData>
        </a:graphic>
      </p:graphicFrame>
      <p:graphicFrame>
        <p:nvGraphicFramePr>
          <p:cNvPr id="11" name="표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38149458"/>
              </p:ext>
            </p:extLst>
          </p:nvPr>
        </p:nvGraphicFramePr>
        <p:xfrm>
          <a:off x="276941" y="5678424"/>
          <a:ext cx="1514065" cy="45690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14065">
                  <a:extLst>
                    <a:ext uri="{9D8B030D-6E8A-4147-A177-3AD203B41FA5}">
                      <a16:colId xmlns:a16="http://schemas.microsoft.com/office/drawing/2014/main" val="3845277698"/>
                    </a:ext>
                  </a:extLst>
                </a:gridCol>
              </a:tblGrid>
              <a:tr h="456906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ular Processes</a:t>
                      </a:r>
                      <a:endParaRPr lang="ko-KR" alt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03158120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642552" y="747360"/>
            <a:ext cx="11484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/>
              <a:t>Level 1</a:t>
            </a:r>
            <a:endParaRPr lang="ko-KR" altLang="en-US" sz="12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3305072" y="718014"/>
            <a:ext cx="11484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/>
              <a:t>Level 3</a:t>
            </a:r>
            <a:endParaRPr lang="ko-KR" altLang="en-US" sz="1200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33AF777-4EA8-490A-8AB2-10C1969AA757}"/>
              </a:ext>
            </a:extLst>
          </p:cNvPr>
          <p:cNvSpPr txBox="1"/>
          <p:nvPr/>
        </p:nvSpPr>
        <p:spPr>
          <a:xfrm>
            <a:off x="213238" y="733532"/>
            <a:ext cx="5915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(A)</a:t>
            </a:r>
            <a:endParaRPr lang="ko-KR" altLang="en-US" sz="1400" b="1" dirty="0"/>
          </a:p>
        </p:txBody>
      </p:sp>
      <p:graphicFrame>
        <p:nvGraphicFramePr>
          <p:cNvPr id="14" name="표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48724757"/>
              </p:ext>
            </p:extLst>
          </p:nvPr>
        </p:nvGraphicFramePr>
        <p:xfrm>
          <a:off x="9029393" y="839728"/>
          <a:ext cx="766916" cy="534753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66916">
                  <a:extLst>
                    <a:ext uri="{9D8B030D-6E8A-4147-A177-3AD203B41FA5}">
                      <a16:colId xmlns:a16="http://schemas.microsoft.com/office/drawing/2014/main" val="1737752281"/>
                    </a:ext>
                  </a:extLst>
                </a:gridCol>
              </a:tblGrid>
              <a:tr h="17825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ko-KR" altLang="en-US" sz="9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2226863"/>
                  </a:ext>
                </a:extLst>
              </a:tr>
              <a:tr h="17825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83072202"/>
                  </a:ext>
                </a:extLst>
              </a:tr>
              <a:tr h="17825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53929134"/>
                  </a:ext>
                </a:extLst>
              </a:tr>
              <a:tr h="17825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5314035"/>
                  </a:ext>
                </a:extLst>
              </a:tr>
              <a:tr h="17825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13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14477103"/>
                  </a:ext>
                </a:extLst>
              </a:tr>
              <a:tr h="17825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7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87845483"/>
                  </a:ext>
                </a:extLst>
              </a:tr>
              <a:tr h="17825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7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40135045"/>
                  </a:ext>
                </a:extLst>
              </a:tr>
              <a:tr h="17825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36202703"/>
                  </a:ext>
                </a:extLst>
              </a:tr>
              <a:tr h="17825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02659828"/>
                  </a:ext>
                </a:extLst>
              </a:tr>
              <a:tr h="17825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7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42572675"/>
                  </a:ext>
                </a:extLst>
              </a:tr>
              <a:tr h="17825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81325077"/>
                  </a:ext>
                </a:extLst>
              </a:tr>
              <a:tr h="17825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68663485"/>
                  </a:ext>
                </a:extLst>
              </a:tr>
              <a:tr h="17825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36872981"/>
                  </a:ext>
                </a:extLst>
              </a:tr>
              <a:tr h="17825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07444028"/>
                  </a:ext>
                </a:extLst>
              </a:tr>
              <a:tr h="17825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57166131"/>
                  </a:ext>
                </a:extLst>
              </a:tr>
              <a:tr h="17825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32115659"/>
                  </a:ext>
                </a:extLst>
              </a:tr>
              <a:tr h="17825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46775745"/>
                  </a:ext>
                </a:extLst>
              </a:tr>
              <a:tr h="17825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35356372"/>
                  </a:ext>
                </a:extLst>
              </a:tr>
              <a:tr h="17825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39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82373522"/>
                  </a:ext>
                </a:extLst>
              </a:tr>
              <a:tr h="17825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5596429"/>
                  </a:ext>
                </a:extLst>
              </a:tr>
              <a:tr h="17825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7795774"/>
                  </a:ext>
                </a:extLst>
              </a:tr>
              <a:tr h="17825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9889984"/>
                  </a:ext>
                </a:extLst>
              </a:tr>
              <a:tr h="17825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19210941"/>
                  </a:ext>
                </a:extLst>
              </a:tr>
              <a:tr h="17825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2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79032411"/>
                  </a:ext>
                </a:extLst>
              </a:tr>
              <a:tr h="17825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39869115"/>
                  </a:ext>
                </a:extLst>
              </a:tr>
              <a:tr h="17825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1945676"/>
                  </a:ext>
                </a:extLst>
              </a:tr>
              <a:tr h="17825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53522198"/>
                  </a:ext>
                </a:extLst>
              </a:tr>
              <a:tr h="17825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79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56478724"/>
                  </a:ext>
                </a:extLst>
              </a:tr>
              <a:tr h="17825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91911423"/>
                  </a:ext>
                </a:extLst>
              </a:tr>
              <a:tr h="17825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5626278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726443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차트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06969158"/>
              </p:ext>
            </p:extLst>
          </p:nvPr>
        </p:nvGraphicFramePr>
        <p:xfrm>
          <a:off x="1991032" y="1024360"/>
          <a:ext cx="7285704" cy="55534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표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15566307"/>
              </p:ext>
            </p:extLst>
          </p:nvPr>
        </p:nvGraphicFramePr>
        <p:xfrm>
          <a:off x="276942" y="1190765"/>
          <a:ext cx="1514065" cy="361523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14065">
                  <a:extLst>
                    <a:ext uri="{9D8B030D-6E8A-4147-A177-3AD203B41FA5}">
                      <a16:colId xmlns:a16="http://schemas.microsoft.com/office/drawing/2014/main" val="3845277698"/>
                    </a:ext>
                  </a:extLst>
                </a:gridCol>
              </a:tblGrid>
              <a:tr h="3615235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abolism</a:t>
                      </a:r>
                      <a:endParaRPr lang="ko-KR" alt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03158120"/>
                  </a:ext>
                </a:extLst>
              </a:tr>
            </a:tbl>
          </a:graphicData>
        </a:graphic>
      </p:graphicFrame>
      <p:graphicFrame>
        <p:nvGraphicFramePr>
          <p:cNvPr id="8" name="표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2946859"/>
              </p:ext>
            </p:extLst>
          </p:nvPr>
        </p:nvGraphicFramePr>
        <p:xfrm>
          <a:off x="276942" y="4955458"/>
          <a:ext cx="1514065" cy="60271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14065">
                  <a:extLst>
                    <a:ext uri="{9D8B030D-6E8A-4147-A177-3AD203B41FA5}">
                      <a16:colId xmlns:a16="http://schemas.microsoft.com/office/drawing/2014/main" val="3845277698"/>
                    </a:ext>
                  </a:extLst>
                </a:gridCol>
              </a:tblGrid>
              <a:tr h="602713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vironmental</a:t>
                      </a:r>
                      <a:r>
                        <a:rPr lang="en-US" altLang="ko-KR" sz="10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formation Processing</a:t>
                      </a:r>
                      <a:endParaRPr lang="ko-KR" alt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03158120"/>
                  </a:ext>
                </a:extLst>
              </a:tr>
            </a:tbl>
          </a:graphicData>
        </a:graphic>
      </p:graphicFrame>
      <p:graphicFrame>
        <p:nvGraphicFramePr>
          <p:cNvPr id="10" name="표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93949219"/>
              </p:ext>
            </p:extLst>
          </p:nvPr>
        </p:nvGraphicFramePr>
        <p:xfrm>
          <a:off x="276941" y="5707628"/>
          <a:ext cx="1514065" cy="243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14065">
                  <a:extLst>
                    <a:ext uri="{9D8B030D-6E8A-4147-A177-3AD203B41FA5}">
                      <a16:colId xmlns:a16="http://schemas.microsoft.com/office/drawing/2014/main" val="3845277698"/>
                    </a:ext>
                  </a:extLst>
                </a:gridCol>
              </a:tblGrid>
              <a:tr h="191729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ular Processes</a:t>
                      </a:r>
                      <a:endParaRPr lang="ko-KR" alt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03158120"/>
                  </a:ext>
                </a:extLst>
              </a:tr>
            </a:tbl>
          </a:graphicData>
        </a:graphic>
      </p:graphicFrame>
      <p:sp>
        <p:nvSpPr>
          <p:cNvPr id="11" name="TextBox 10"/>
          <p:cNvSpPr txBox="1"/>
          <p:nvPr/>
        </p:nvSpPr>
        <p:spPr>
          <a:xfrm>
            <a:off x="642552" y="747360"/>
            <a:ext cx="11484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/>
              <a:t>Level 1</a:t>
            </a:r>
            <a:endParaRPr lang="ko-KR" altLang="en-US" sz="1200" b="1" dirty="0"/>
          </a:p>
        </p:txBody>
      </p:sp>
      <p:graphicFrame>
        <p:nvGraphicFramePr>
          <p:cNvPr id="2" name="표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75823029"/>
              </p:ext>
            </p:extLst>
          </p:nvPr>
        </p:nvGraphicFramePr>
        <p:xfrm>
          <a:off x="9188245" y="825037"/>
          <a:ext cx="766916" cy="512643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66916">
                  <a:extLst>
                    <a:ext uri="{9D8B030D-6E8A-4147-A177-3AD203B41FA5}">
                      <a16:colId xmlns:a16="http://schemas.microsoft.com/office/drawing/2014/main" val="1737752281"/>
                    </a:ext>
                  </a:extLst>
                </a:gridCol>
              </a:tblGrid>
              <a:tr h="28480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ko-KR" altLang="en-US" sz="9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2226863"/>
                  </a:ext>
                </a:extLst>
              </a:tr>
              <a:tr h="28480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83072202"/>
                  </a:ext>
                </a:extLst>
              </a:tr>
              <a:tr h="28480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53929134"/>
                  </a:ext>
                </a:extLst>
              </a:tr>
              <a:tr h="28480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5314035"/>
                  </a:ext>
                </a:extLst>
              </a:tr>
              <a:tr h="28480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97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14477103"/>
                  </a:ext>
                </a:extLst>
              </a:tr>
              <a:tr h="28480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39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87845483"/>
                  </a:ext>
                </a:extLst>
              </a:tr>
              <a:tr h="28480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40135045"/>
                  </a:ext>
                </a:extLst>
              </a:tr>
              <a:tr h="28480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36202703"/>
                  </a:ext>
                </a:extLst>
              </a:tr>
              <a:tr h="28480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02659828"/>
                  </a:ext>
                </a:extLst>
              </a:tr>
              <a:tr h="28480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42572675"/>
                  </a:ext>
                </a:extLst>
              </a:tr>
              <a:tr h="28480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81325077"/>
                  </a:ext>
                </a:extLst>
              </a:tr>
              <a:tr h="28480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68663485"/>
                  </a:ext>
                </a:extLst>
              </a:tr>
              <a:tr h="28480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36872981"/>
                  </a:ext>
                </a:extLst>
              </a:tr>
              <a:tr h="28480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07444028"/>
                  </a:ext>
                </a:extLst>
              </a:tr>
              <a:tr h="28480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57166131"/>
                  </a:ext>
                </a:extLst>
              </a:tr>
              <a:tr h="28480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32115659"/>
                  </a:ext>
                </a:extLst>
              </a:tr>
              <a:tr h="28480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46775745"/>
                  </a:ext>
                </a:extLst>
              </a:tr>
              <a:tr h="28480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4</a:t>
                      </a:r>
                      <a:endParaRPr lang="ko-KR" altLang="en-US" sz="9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35356372"/>
                  </a:ext>
                </a:extLst>
              </a:tr>
            </a:tbl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233AF777-4EA8-490A-8AB2-10C1969AA757}"/>
              </a:ext>
            </a:extLst>
          </p:cNvPr>
          <p:cNvSpPr txBox="1"/>
          <p:nvPr/>
        </p:nvSpPr>
        <p:spPr>
          <a:xfrm>
            <a:off x="213238" y="733532"/>
            <a:ext cx="5915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(B)</a:t>
            </a:r>
            <a:endParaRPr lang="ko-KR" altLang="en-US" sz="14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3305072" y="718014"/>
            <a:ext cx="11484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/>
              <a:t>Level 3</a:t>
            </a:r>
            <a:endParaRPr lang="ko-KR" altLang="en-US" sz="1200" b="1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073C4B9-2918-0BA0-0DBE-7F12A5F3E71B}"/>
              </a:ext>
            </a:extLst>
          </p:cNvPr>
          <p:cNvSpPr txBox="1"/>
          <p:nvPr/>
        </p:nvSpPr>
        <p:spPr>
          <a:xfrm>
            <a:off x="276942" y="243159"/>
            <a:ext cx="78916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200" b="1" dirty="0"/>
              <a:t>Fig. S1. Dominant functional pathway of bacteria and BEVs in (A) air and (B) soil.</a:t>
            </a:r>
          </a:p>
        </p:txBody>
      </p:sp>
    </p:spTree>
    <p:extLst>
      <p:ext uri="{BB962C8B-B14F-4D97-AF65-F5344CB8AC3E}">
        <p14:creationId xmlns:p14="http://schemas.microsoft.com/office/powerpoint/2010/main" val="336874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7</TotalTime>
  <Words>151</Words>
  <Application>Microsoft Office PowerPoint</Application>
  <PresentationFormat>와이드스크린</PresentationFormat>
  <Paragraphs>65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6" baseType="lpstr">
      <vt:lpstr>맑은 고딕</vt:lpstr>
      <vt:lpstr>Arial</vt:lpstr>
      <vt:lpstr>Times New Roman</vt:lpstr>
      <vt:lpstr>Office 테마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Microsoft Office 사용자</dc:creator>
  <cp:lastModifiedBy>양진호/세명대</cp:lastModifiedBy>
  <cp:revision>57</cp:revision>
  <dcterms:created xsi:type="dcterms:W3CDTF">2020-02-11T12:28:03Z</dcterms:created>
  <dcterms:modified xsi:type="dcterms:W3CDTF">2025-03-02T05:14:10Z</dcterms:modified>
</cp:coreProperties>
</file>